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258" autoAdjust="0"/>
  </p:normalViewPr>
  <p:slideViewPr>
    <p:cSldViewPr>
      <p:cViewPr>
        <p:scale>
          <a:sx n="100" d="100"/>
          <a:sy n="100" d="100"/>
        </p:scale>
        <p:origin x="-72" y="-72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E1155E-9319-4B35-9CA6-414D330DBA98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FE0E3F-01D4-4817-B65E-0B34BEF5F5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1974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FE0E3F-01D4-4817-B65E-0B34BEF5F5F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87269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181850" y="274640"/>
            <a:ext cx="222885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95300" y="274640"/>
            <a:ext cx="652145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95302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95302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5032113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5032113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95302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95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6/10/2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384550" y="6356352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7099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704528" y="4654543"/>
            <a:ext cx="4768608" cy="1582769"/>
            <a:chOff x="-15552" y="4798559"/>
            <a:chExt cx="4768608" cy="1582769"/>
          </a:xfrm>
        </p:grpSpPr>
        <p:sp>
          <p:nvSpPr>
            <p:cNvPr id="41" name="正方形/長方形 40"/>
            <p:cNvSpPr/>
            <p:nvPr/>
          </p:nvSpPr>
          <p:spPr>
            <a:xfrm>
              <a:off x="3888534" y="4852527"/>
              <a:ext cx="64800" cy="756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91" name="正方形/長方形 90"/>
            <p:cNvSpPr>
              <a:spLocks noChangeAspect="1"/>
            </p:cNvSpPr>
            <p:nvPr/>
          </p:nvSpPr>
          <p:spPr>
            <a:xfrm>
              <a:off x="-15552" y="4798559"/>
              <a:ext cx="4768608" cy="147732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Pigeon 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IGLL-1          </a:t>
              </a:r>
              <a:r>
                <a:rPr lang="ja-JP" altLang="en-US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MASSYLTLTPSQWRSKETFTCKVTHAAGNVQKTVKR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ECSS 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232 </a:t>
              </a:r>
              <a:endParaRPr lang="en-US" altLang="ja-JP" sz="1000" dirty="0" smtClean="0">
                <a:latin typeface="ＭＳ ゴシック" panose="020B0609070205080204" pitchFamily="49" charset="-128"/>
                <a:ea typeface="ＭＳ ゴシック" panose="020B0609070205080204" pitchFamily="49" charset="-128"/>
                <a:cs typeface="Courier New" panose="02070309020205020404" pitchFamily="49" charset="0"/>
              </a:endParaRP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Duck Ig lambda chain    MASSYLTLSASEWKGANSVVCQVTHDGTPIEKTLNK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EC–- 230</a:t>
              </a: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Goose Ig light chain    MASSYLTLSATEWKTVQSFSCQVTHEGAVTEKTLNK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ECS- 233</a:t>
              </a: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Chicken Ig light chain  MASSYLSLSASDWSSHETYTCRVTHDGTSITKTLKR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EC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- 231 </a:t>
              </a:r>
              <a:endParaRPr lang="en-US" altLang="ja-JP" sz="1000" dirty="0" smtClean="0">
                <a:latin typeface="ＭＳ ゴシック" panose="020B0609070205080204" pitchFamily="49" charset="-128"/>
                <a:ea typeface="ＭＳ ゴシック" panose="020B0609070205080204" pitchFamily="49" charset="-128"/>
                <a:cs typeface="Courier New" panose="02070309020205020404" pitchFamily="49" charset="0"/>
              </a:endParaRP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Parakeet IGLL-1         VASSYLTLGLSDWQGHENYSCKVKHEAGDVEKSLNR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ECS- 231</a:t>
              </a:r>
            </a:p>
            <a:p>
              <a:endParaRPr lang="en-US" altLang="ja-JP" sz="1000" dirty="0" smtClean="0">
                <a:latin typeface="ＭＳ ゴシック" panose="020B0609070205080204" pitchFamily="49" charset="-128"/>
                <a:ea typeface="ＭＳ ゴシック" panose="020B0609070205080204" pitchFamily="49" charset="-128"/>
                <a:cs typeface="Courier New" panose="02070309020205020404" pitchFamily="49" charset="0"/>
              </a:endParaRP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Monkey Ig lambda chain  AASSYLSLTSDQWKSHKSYSCQVTHEGSTVEKTVAPAECS- 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231 </a:t>
              </a:r>
              <a:endParaRPr lang="en-US" altLang="ja-JP" sz="1000" dirty="0" smtClean="0">
                <a:latin typeface="ＭＳ ゴシック" panose="020B0609070205080204" pitchFamily="49" charset="-128"/>
                <a:ea typeface="ＭＳ ゴシック" panose="020B0609070205080204" pitchFamily="49" charset="-128"/>
                <a:cs typeface="Courier New" panose="02070309020205020404" pitchFamily="49" charset="0"/>
              </a:endParaRP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Gorilla IGLL-5          AASSYLSLTPEQWKSHKSYSCQVTHEGSTVEKTVAPTECS- 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235 </a:t>
              </a:r>
              <a:endParaRPr lang="en-US" altLang="ja-JP" sz="1000" dirty="0" smtClean="0">
                <a:latin typeface="ＭＳ ゴシック" panose="020B0609070205080204" pitchFamily="49" charset="-128"/>
                <a:ea typeface="ＭＳ ゴシック" panose="020B0609070205080204" pitchFamily="49" charset="-128"/>
                <a:cs typeface="Courier New" panose="02070309020205020404" pitchFamily="49" charset="0"/>
              </a:endParaRP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Human Ig lambda chain   AASSYLSLTPEQWKSHRSYSCQVTHEGSTVEKTVAPTECS- 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233</a:t>
              </a:r>
              <a:endParaRPr lang="ja-JP" altLang="en-US" sz="1000" dirty="0">
                <a:latin typeface="ＭＳ ゴシック" panose="020B0609070205080204" pitchFamily="49" charset="-128"/>
                <a:ea typeface="ＭＳ ゴシック" panose="020B0609070205080204" pitchFamily="49" charset="-128"/>
                <a:cs typeface="Courier New" panose="02070309020205020404" pitchFamily="49" charset="0"/>
              </a:endParaRPr>
            </a:p>
          </p:txBody>
        </p:sp>
        <p:sp>
          <p:nvSpPr>
            <p:cNvPr id="32" name="正方形/長方形 31"/>
            <p:cNvSpPr/>
            <p:nvPr/>
          </p:nvSpPr>
          <p:spPr>
            <a:xfrm>
              <a:off x="1602329" y="6308160"/>
              <a:ext cx="2286205" cy="7316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43" name="正方形/長方形 42"/>
            <p:cNvSpPr/>
            <p:nvPr/>
          </p:nvSpPr>
          <p:spPr>
            <a:xfrm>
              <a:off x="3949662" y="4852527"/>
              <a:ext cx="126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44" name="正方形/長方形 43"/>
            <p:cNvSpPr/>
            <p:nvPr/>
          </p:nvSpPr>
          <p:spPr>
            <a:xfrm>
              <a:off x="3566614" y="4852527"/>
              <a:ext cx="648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45" name="正方形/長方形 44"/>
            <p:cNvSpPr/>
            <p:nvPr/>
          </p:nvSpPr>
          <p:spPr>
            <a:xfrm>
              <a:off x="3128669" y="4853222"/>
              <a:ext cx="54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46" name="正方形/長方形 45"/>
            <p:cNvSpPr/>
            <p:nvPr/>
          </p:nvSpPr>
          <p:spPr>
            <a:xfrm>
              <a:off x="2360712" y="4853223"/>
              <a:ext cx="66373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47" name="正方形/長方形 46"/>
            <p:cNvSpPr/>
            <p:nvPr/>
          </p:nvSpPr>
          <p:spPr>
            <a:xfrm>
              <a:off x="2044886" y="4853912"/>
              <a:ext cx="648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48" name="正方形/長方形 47"/>
            <p:cNvSpPr/>
            <p:nvPr/>
          </p:nvSpPr>
          <p:spPr>
            <a:xfrm>
              <a:off x="2998419" y="4853912"/>
              <a:ext cx="648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49" name="正方形/長方形 48"/>
            <p:cNvSpPr/>
            <p:nvPr/>
          </p:nvSpPr>
          <p:spPr>
            <a:xfrm>
              <a:off x="2869717" y="4853222"/>
              <a:ext cx="64977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50" name="正方形/長方形 49"/>
            <p:cNvSpPr/>
            <p:nvPr/>
          </p:nvSpPr>
          <p:spPr>
            <a:xfrm>
              <a:off x="1667102" y="4853223"/>
              <a:ext cx="3132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</p:grpSp>
      <p:grpSp>
        <p:nvGrpSpPr>
          <p:cNvPr id="3" name="グループ化 2"/>
          <p:cNvGrpSpPr>
            <a:grpSpLocks noChangeAspect="1"/>
          </p:cNvGrpSpPr>
          <p:nvPr/>
        </p:nvGrpSpPr>
        <p:grpSpPr>
          <a:xfrm>
            <a:off x="704528" y="2636912"/>
            <a:ext cx="8352928" cy="1800200"/>
            <a:chOff x="-15552" y="2276872"/>
            <a:chExt cx="8352928" cy="1800200"/>
          </a:xfrm>
        </p:grpSpPr>
        <p:sp>
          <p:nvSpPr>
            <p:cNvPr id="29" name="正方形/長方形 28"/>
            <p:cNvSpPr/>
            <p:nvPr/>
          </p:nvSpPr>
          <p:spPr>
            <a:xfrm>
              <a:off x="1598224" y="3788460"/>
              <a:ext cx="2027843" cy="7258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31" name="正方形/長方形 30"/>
            <p:cNvSpPr/>
            <p:nvPr/>
          </p:nvSpPr>
          <p:spPr>
            <a:xfrm>
              <a:off x="3944888" y="3788460"/>
              <a:ext cx="4016384" cy="7258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5496402" y="3861628"/>
              <a:ext cx="11138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g-C domain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正方形/長方形 38"/>
            <p:cNvSpPr/>
            <p:nvPr/>
          </p:nvSpPr>
          <p:spPr>
            <a:xfrm>
              <a:off x="1981725" y="2331536"/>
              <a:ext cx="64800" cy="756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51" name="正方形/長方形 50"/>
            <p:cNvSpPr/>
            <p:nvPr/>
          </p:nvSpPr>
          <p:spPr>
            <a:xfrm>
              <a:off x="7889271" y="2331538"/>
              <a:ext cx="72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52" name="正方形/長方形 51"/>
            <p:cNvSpPr/>
            <p:nvPr/>
          </p:nvSpPr>
          <p:spPr>
            <a:xfrm>
              <a:off x="7574091" y="2331538"/>
              <a:ext cx="180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53" name="正方形/長方形 52"/>
            <p:cNvSpPr/>
            <p:nvPr/>
          </p:nvSpPr>
          <p:spPr>
            <a:xfrm>
              <a:off x="7189860" y="2331538"/>
              <a:ext cx="576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54" name="正方形/長方形 53"/>
            <p:cNvSpPr/>
            <p:nvPr/>
          </p:nvSpPr>
          <p:spPr>
            <a:xfrm>
              <a:off x="6357664" y="2331536"/>
              <a:ext cx="684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55" name="正方形/長方形 54"/>
            <p:cNvSpPr/>
            <p:nvPr/>
          </p:nvSpPr>
          <p:spPr>
            <a:xfrm>
              <a:off x="6229772" y="2331538"/>
              <a:ext cx="684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56" name="正方形/長方形 55"/>
            <p:cNvSpPr/>
            <p:nvPr/>
          </p:nvSpPr>
          <p:spPr>
            <a:xfrm>
              <a:off x="5790131" y="2331537"/>
              <a:ext cx="1872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57" name="正方形/長方形 56"/>
            <p:cNvSpPr/>
            <p:nvPr/>
          </p:nvSpPr>
          <p:spPr>
            <a:xfrm>
              <a:off x="5154625" y="2331537"/>
              <a:ext cx="446192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58" name="正方形/長方形 57"/>
            <p:cNvSpPr/>
            <p:nvPr/>
          </p:nvSpPr>
          <p:spPr>
            <a:xfrm>
              <a:off x="4397206" y="2331537"/>
              <a:ext cx="2484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59" name="正方形/長方形 58"/>
            <p:cNvSpPr/>
            <p:nvPr/>
          </p:nvSpPr>
          <p:spPr>
            <a:xfrm>
              <a:off x="4077984" y="2331537"/>
              <a:ext cx="54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60" name="正方形/長方形 59"/>
            <p:cNvSpPr/>
            <p:nvPr/>
          </p:nvSpPr>
          <p:spPr>
            <a:xfrm>
              <a:off x="3440832" y="2331536"/>
              <a:ext cx="126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61" name="正方形/長方形 60"/>
            <p:cNvSpPr/>
            <p:nvPr/>
          </p:nvSpPr>
          <p:spPr>
            <a:xfrm>
              <a:off x="3253477" y="2331537"/>
              <a:ext cx="1188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62" name="正方形/長方形 61"/>
            <p:cNvSpPr/>
            <p:nvPr/>
          </p:nvSpPr>
          <p:spPr>
            <a:xfrm>
              <a:off x="3056752" y="2331537"/>
              <a:ext cx="1332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63" name="正方形/長方形 62"/>
            <p:cNvSpPr/>
            <p:nvPr/>
          </p:nvSpPr>
          <p:spPr>
            <a:xfrm>
              <a:off x="1730623" y="2331536"/>
              <a:ext cx="252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64" name="正方形/長方形 63"/>
            <p:cNvSpPr/>
            <p:nvPr/>
          </p:nvSpPr>
          <p:spPr>
            <a:xfrm>
              <a:off x="2046526" y="2331537"/>
              <a:ext cx="62132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65" name="正方形/長方形 64"/>
            <p:cNvSpPr/>
            <p:nvPr/>
          </p:nvSpPr>
          <p:spPr>
            <a:xfrm>
              <a:off x="2173457" y="2331537"/>
              <a:ext cx="61876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66" name="正方形/長方形 65"/>
            <p:cNvSpPr/>
            <p:nvPr/>
          </p:nvSpPr>
          <p:spPr>
            <a:xfrm>
              <a:off x="1598224" y="2331536"/>
              <a:ext cx="684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86" name="正方形/長方形 85"/>
            <p:cNvSpPr/>
            <p:nvPr/>
          </p:nvSpPr>
          <p:spPr>
            <a:xfrm>
              <a:off x="3816373" y="2331537"/>
              <a:ext cx="648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42" name="正方形/長方形 41"/>
            <p:cNvSpPr/>
            <p:nvPr/>
          </p:nvSpPr>
          <p:spPr>
            <a:xfrm>
              <a:off x="-15552" y="2276872"/>
              <a:ext cx="8352928" cy="147732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Pigeon IGLL-1           QAEDEA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V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YYCGGYDGST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---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DIFGAGTQLTISNLPRSAPEVSLFPPSSELLE-QNKATLVCLIENFYPRDVTVAWLADGNTITDGVSTSQPQWQSNTKY 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191</a:t>
              </a:r>
              <a:endParaRPr lang="en-US" altLang="ja-JP" sz="1000" dirty="0" smtClean="0">
                <a:latin typeface="ＭＳ ゴシック" panose="020B0609070205080204" pitchFamily="49" charset="-128"/>
                <a:ea typeface="ＭＳ ゴシック" panose="020B0609070205080204" pitchFamily="49" charset="-128"/>
                <a:cs typeface="Courier New" panose="02070309020205020404" pitchFamily="49" charset="0"/>
              </a:endParaRP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Duck Ig lambda chain    QAEDEA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V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YYCGSYDSSY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--VGVFGAGTTLTVLGQPKVSPTVHVFPPSDEEISSQNKATLVCLMSDFYPSPVTVTWKVNGSTRSSGVETSASQRQSNSKY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191</a:t>
              </a: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Goose</a:t>
              </a:r>
              <a:r>
                <a:rPr lang="ja-JP" altLang="en-US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Ig light chain    QAEDEA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V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YYCATWDS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------VFGAGTALTVLGQPKASPSIYLFPPSSDEIDSQNKATLVCLMSDFYPSPVQVTWKVDGSTRTSGVETSASQRQSNNQY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193</a:t>
              </a: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Chicken Ig light chain  QAEDEA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V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YFCGGYDSDTGN-RDIFGAGTILTVLGQPKVAPTITLFPPSKEELNEATKATLVCLINDFYPSPVTVDWVIDGSTRSG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-ETTAPQRQSNSQY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192</a:t>
              </a: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Parakeet IGLL-1         QPEDEA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V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YYCGSWDGSM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--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CGVFGSGTMLTVLGQPKVSPTVYLFPPSSEQIQSEKKATLVCLLGEFYPGTMEVIWTADGKVISNGVDTSLAVRQSNNKY 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191</a:t>
              </a:r>
              <a:endParaRPr lang="en-US" altLang="ja-JP" sz="1000" dirty="0" smtClean="0">
                <a:latin typeface="ＭＳ ゴシック" panose="020B0609070205080204" pitchFamily="49" charset="-128"/>
                <a:ea typeface="ＭＳ ゴシック" panose="020B0609070205080204" pitchFamily="49" charset="-128"/>
                <a:cs typeface="Courier New" panose="02070309020205020404" pitchFamily="49" charset="0"/>
              </a:endParaRPr>
            </a:p>
            <a:p>
              <a:endParaRPr lang="en-US" altLang="ja-JP" sz="1000" dirty="0" smtClean="0">
                <a:latin typeface="ＭＳ ゴシック" panose="020B0609070205080204" pitchFamily="49" charset="-128"/>
                <a:ea typeface="ＭＳ ゴシック" panose="020B0609070205080204" pitchFamily="49" charset="-128"/>
                <a:cs typeface="Courier New" panose="02070309020205020404" pitchFamily="49" charset="0"/>
              </a:endParaRP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Monkey Ig lambda chain  QAEDEADYYCQS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-SSGYH--WVFGGGTRLTVLGQPKAAPSVTLFPPSSEELQ-ANKATLVCLISDFYPGAVEVAWKADGSAVNAGVETTKPSKQSNNKY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191</a:t>
              </a: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Gorilla</a:t>
              </a:r>
              <a:r>
                <a:rPr lang="ja-JP" altLang="en-US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 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IGLL-5        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 QVEDEADYYCYSTDSSGYPGCVVFGGGTKLTVLGQPKAAPSVTLFPPSSEELQ-ANKATLVCLISDFYPGAVTVAWKADGSPVKAGVETTTPSKQSNNKY 195</a:t>
              </a: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Human Ig lambda chain   QSEDEADYYCATWDDS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---TVVFGGGTKLTVPGQPKAAPSVTLFPPSSEELQ-ANKATLVCLISDFYPGAVTVAWKADSSPVKAGVETTTPSKQSNNKY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Courier New" panose="02070309020205020404" pitchFamily="49" charset="0"/>
                </a:rPr>
                <a:t>193</a:t>
              </a:r>
            </a:p>
          </p:txBody>
        </p:sp>
      </p:grpSp>
      <p:grpSp>
        <p:nvGrpSpPr>
          <p:cNvPr id="2" name="グループ化 1"/>
          <p:cNvGrpSpPr/>
          <p:nvPr/>
        </p:nvGrpSpPr>
        <p:grpSpPr>
          <a:xfrm>
            <a:off x="704528" y="620688"/>
            <a:ext cx="8352928" cy="1800200"/>
            <a:chOff x="-15552" y="260648"/>
            <a:chExt cx="8352928" cy="1800200"/>
          </a:xfrm>
        </p:grpSpPr>
        <p:sp>
          <p:nvSpPr>
            <p:cNvPr id="92" name="正方形/長方形 91"/>
            <p:cNvSpPr/>
            <p:nvPr/>
          </p:nvSpPr>
          <p:spPr>
            <a:xfrm>
              <a:off x="4391922" y="303424"/>
              <a:ext cx="64800" cy="756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24" name="正方形/長方形 23"/>
            <p:cNvSpPr/>
            <p:nvPr/>
          </p:nvSpPr>
          <p:spPr>
            <a:xfrm>
              <a:off x="2288704" y="303425"/>
              <a:ext cx="72000" cy="756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95" name="正方形/長方形 94"/>
            <p:cNvSpPr/>
            <p:nvPr/>
          </p:nvSpPr>
          <p:spPr>
            <a:xfrm>
              <a:off x="2484357" y="303425"/>
              <a:ext cx="72000" cy="756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35" name="正方形/長方形 34"/>
            <p:cNvSpPr/>
            <p:nvPr/>
          </p:nvSpPr>
          <p:spPr>
            <a:xfrm>
              <a:off x="2868384" y="303425"/>
              <a:ext cx="129600" cy="756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34" name="正方形/長方形 33"/>
            <p:cNvSpPr/>
            <p:nvPr/>
          </p:nvSpPr>
          <p:spPr>
            <a:xfrm>
              <a:off x="2676516" y="303425"/>
              <a:ext cx="129600" cy="756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83" name="正方形/長方形 82"/>
            <p:cNvSpPr/>
            <p:nvPr/>
          </p:nvSpPr>
          <p:spPr>
            <a:xfrm>
              <a:off x="2108657" y="303425"/>
              <a:ext cx="64800" cy="756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26" name="正方形/長方形 25"/>
            <p:cNvSpPr/>
            <p:nvPr/>
          </p:nvSpPr>
          <p:spPr>
            <a:xfrm>
              <a:off x="1568625" y="1772816"/>
              <a:ext cx="1364560" cy="6375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1704029" y="1845404"/>
              <a:ext cx="11138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gnal peptide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正方形/長方形 27"/>
            <p:cNvSpPr/>
            <p:nvPr/>
          </p:nvSpPr>
          <p:spPr>
            <a:xfrm>
              <a:off x="3240462" y="1772816"/>
              <a:ext cx="4720708" cy="72588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5043870" y="1845404"/>
              <a:ext cx="11138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g-like domain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正方形/長方形 35"/>
            <p:cNvSpPr/>
            <p:nvPr/>
          </p:nvSpPr>
          <p:spPr>
            <a:xfrm>
              <a:off x="5025008" y="303425"/>
              <a:ext cx="64800" cy="75599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37" name="正方形/長方形 36"/>
            <p:cNvSpPr/>
            <p:nvPr/>
          </p:nvSpPr>
          <p:spPr>
            <a:xfrm>
              <a:off x="5854190" y="303193"/>
              <a:ext cx="61200" cy="756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38" name="正方形/長方形 37"/>
            <p:cNvSpPr/>
            <p:nvPr/>
          </p:nvSpPr>
          <p:spPr>
            <a:xfrm>
              <a:off x="7889169" y="303425"/>
              <a:ext cx="72000" cy="756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40" name="正方形/長方形 39"/>
            <p:cNvSpPr/>
            <p:nvPr/>
          </p:nvSpPr>
          <p:spPr>
            <a:xfrm>
              <a:off x="7318584" y="303192"/>
              <a:ext cx="61200" cy="756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67" name="正方形/長方形 66"/>
            <p:cNvSpPr/>
            <p:nvPr/>
          </p:nvSpPr>
          <p:spPr>
            <a:xfrm>
              <a:off x="7827969" y="302273"/>
              <a:ext cx="612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68" name="正方形/長方形 67"/>
            <p:cNvSpPr/>
            <p:nvPr/>
          </p:nvSpPr>
          <p:spPr>
            <a:xfrm>
              <a:off x="7185248" y="303192"/>
              <a:ext cx="133336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70" name="正方形/長方形 69"/>
            <p:cNvSpPr/>
            <p:nvPr/>
          </p:nvSpPr>
          <p:spPr>
            <a:xfrm>
              <a:off x="6802713" y="303426"/>
              <a:ext cx="1944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71" name="正方形/長方形 70"/>
            <p:cNvSpPr/>
            <p:nvPr/>
          </p:nvSpPr>
          <p:spPr>
            <a:xfrm>
              <a:off x="6426064" y="303192"/>
              <a:ext cx="126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72" name="正方形/長方形 71"/>
            <p:cNvSpPr/>
            <p:nvPr/>
          </p:nvSpPr>
          <p:spPr>
            <a:xfrm>
              <a:off x="5999348" y="303425"/>
              <a:ext cx="108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73" name="正方形/長方形 72"/>
            <p:cNvSpPr/>
            <p:nvPr/>
          </p:nvSpPr>
          <p:spPr>
            <a:xfrm>
              <a:off x="5476273" y="303426"/>
              <a:ext cx="1224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74" name="正方形/長方形 73"/>
            <p:cNvSpPr/>
            <p:nvPr/>
          </p:nvSpPr>
          <p:spPr>
            <a:xfrm>
              <a:off x="4147751" y="303424"/>
              <a:ext cx="180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75" name="正方形/長方形 74"/>
            <p:cNvSpPr/>
            <p:nvPr/>
          </p:nvSpPr>
          <p:spPr>
            <a:xfrm>
              <a:off x="5221904" y="303426"/>
              <a:ext cx="684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77" name="正方形/長方形 76"/>
            <p:cNvSpPr/>
            <p:nvPr/>
          </p:nvSpPr>
          <p:spPr>
            <a:xfrm>
              <a:off x="3692860" y="303424"/>
              <a:ext cx="72007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78" name="正方形/長方形 77"/>
            <p:cNvSpPr/>
            <p:nvPr/>
          </p:nvSpPr>
          <p:spPr>
            <a:xfrm>
              <a:off x="3440832" y="303425"/>
              <a:ext cx="648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79" name="正方形/長方形 78"/>
            <p:cNvSpPr/>
            <p:nvPr/>
          </p:nvSpPr>
          <p:spPr>
            <a:xfrm>
              <a:off x="3323095" y="303426"/>
              <a:ext cx="54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80" name="正方形/長方形 79"/>
            <p:cNvSpPr/>
            <p:nvPr/>
          </p:nvSpPr>
          <p:spPr>
            <a:xfrm>
              <a:off x="3119787" y="303425"/>
              <a:ext cx="72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81" name="正方形/長方形 80"/>
            <p:cNvSpPr/>
            <p:nvPr/>
          </p:nvSpPr>
          <p:spPr>
            <a:xfrm>
              <a:off x="2608116" y="303424"/>
              <a:ext cx="684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82" name="正方形/長方形 81"/>
            <p:cNvSpPr/>
            <p:nvPr/>
          </p:nvSpPr>
          <p:spPr>
            <a:xfrm>
              <a:off x="2235775" y="303424"/>
              <a:ext cx="504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84" name="正方形/長方形 83"/>
            <p:cNvSpPr/>
            <p:nvPr/>
          </p:nvSpPr>
          <p:spPr>
            <a:xfrm>
              <a:off x="1856657" y="303424"/>
              <a:ext cx="252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85" name="正方形/長方形 84"/>
            <p:cNvSpPr/>
            <p:nvPr/>
          </p:nvSpPr>
          <p:spPr>
            <a:xfrm>
              <a:off x="1568623" y="303425"/>
              <a:ext cx="1620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87" name="正方形/長方形 86"/>
            <p:cNvSpPr/>
            <p:nvPr/>
          </p:nvSpPr>
          <p:spPr>
            <a:xfrm>
              <a:off x="5093424" y="303425"/>
              <a:ext cx="612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89" name="正方形/長方形 88"/>
            <p:cNvSpPr/>
            <p:nvPr/>
          </p:nvSpPr>
          <p:spPr>
            <a:xfrm>
              <a:off x="6681192" y="303426"/>
              <a:ext cx="612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90" name="正方形/長方形 89"/>
            <p:cNvSpPr/>
            <p:nvPr/>
          </p:nvSpPr>
          <p:spPr>
            <a:xfrm>
              <a:off x="7558743" y="302274"/>
              <a:ext cx="77254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76" name="正方形/長方形 75"/>
            <p:cNvSpPr/>
            <p:nvPr/>
          </p:nvSpPr>
          <p:spPr>
            <a:xfrm>
              <a:off x="4016897" y="303426"/>
              <a:ext cx="612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94" name="正方形/長方形 93"/>
            <p:cNvSpPr/>
            <p:nvPr/>
          </p:nvSpPr>
          <p:spPr>
            <a:xfrm>
              <a:off x="5725331" y="303193"/>
              <a:ext cx="64800" cy="1368000"/>
            </a:xfrm>
            <a:prstGeom prst="rect">
              <a:avLst/>
            </a:prstGeom>
            <a:solidFill>
              <a:schemeClr val="bg1">
                <a:lumMod val="75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/>
            </a:p>
          </p:txBody>
        </p:sp>
        <p:sp>
          <p:nvSpPr>
            <p:cNvPr id="93" name="正方形/長方形 92"/>
            <p:cNvSpPr/>
            <p:nvPr/>
          </p:nvSpPr>
          <p:spPr>
            <a:xfrm>
              <a:off x="-15552" y="260648"/>
              <a:ext cx="8352928" cy="147732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Pigeon</a:t>
              </a:r>
              <a:r>
                <a:rPr lang="ja-JP" altLang="en-US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IGLL-1           MAWLPLLL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L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HG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GS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LV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Q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LTQPPSVSTTLGETIRITCSGL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SSN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---A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G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WYQQKVPGTGPV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T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MIYGNTGRPSGIPPRFSGTKSG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TATLTITG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96</a:t>
              </a:r>
              <a:endParaRPr lang="en-US" altLang="ja-JP" sz="1000" dirty="0">
                <a:latin typeface="ＭＳ ゴシック" panose="020B0609070205080204" pitchFamily="49" charset="-128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Duck Ig lambda chain    MAWAPLLL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L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HT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GS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LV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Q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LTQPASKSVNPGDTVQITCSGS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D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-----Y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G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WFQQKTPGSAPV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T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IYQNNKRPSGIPSRFSGSKSG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TATLTITG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94</a:t>
              </a: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Goose Ig light chain</a:t>
              </a:r>
              <a:r>
                <a:rPr lang="ja-JP" altLang="en-US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  </a:t>
              </a:r>
              <a:r>
                <a:rPr lang="ja-JP" altLang="en-US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 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MAWAPLLL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L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HT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GS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LV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Q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SQPASKSVNPGDTVQITCSGG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DING---Y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G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WFQQKTPGSAPV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T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IYQNNKRPSGIPSRFSGSKSG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TATLTITG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 94</a:t>
              </a: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Chicken Ig light chain</a:t>
              </a:r>
              <a:r>
                <a:rPr lang="ja-JP" altLang="en-US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 </a:t>
              </a:r>
              <a:r>
                <a:rPr lang="ja-JP" altLang="en-US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MAWAPLLL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L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HT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GS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LV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Q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LTQPASVSANPGETVKITCSGS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GS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----WY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G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WFQQKSPGSAPV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T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IYSNDKRPSNIPSRFSGSKSG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TGTLTIIG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</a:t>
              </a:r>
              <a:r>
                <a:rPr lang="en-US" altLang="ja-JP" sz="1000" b="1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95</a:t>
              </a: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Parakeet IGLL-1</a:t>
              </a:r>
              <a:r>
                <a:rPr lang="ja-JP" altLang="en-US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　      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MAWAPLLL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LL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HG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GS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LV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Q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AA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LTQPPSLSVEPGKNAQITCSGS</a:t>
              </a:r>
              <a:r>
                <a:rPr lang="en-US" altLang="ja-JP" sz="1000" b="1" dirty="0" smtClean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NS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-----Y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G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WYQQKVPGSAPI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T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IYWSDQRPSGIPSRFSGSKSG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S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TATLTITG</a:t>
              </a:r>
              <a:r>
                <a:rPr lang="en-US" altLang="ja-JP" sz="1000" b="1" dirty="0">
                  <a:solidFill>
                    <a:schemeClr val="bg1"/>
                  </a:solidFill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V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94</a:t>
              </a:r>
            </a:p>
            <a:p>
              <a:endParaRPr lang="en-US" altLang="ja-JP" sz="1000" dirty="0" smtClean="0">
                <a:latin typeface="ＭＳ ゴシック" panose="020B0609070205080204" pitchFamily="49" charset="-128"/>
                <a:ea typeface="ＭＳ ゴシック" panose="020B0609070205080204" pitchFamily="49" charset="-128"/>
                <a:cs typeface="Arial" panose="020B0604020202020204" pitchFamily="34" charset="0"/>
              </a:endParaRP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Monkey Ig lambda chain  MAWAPLLLPLLTFCTGSAASYVLTQPPSVSVSPGQTARITCSG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-ELVAEK-YTQWFQRK-PGQAPLQVIYKDTERPSGIPERFSSSSSGTTVTLTISGA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96</a:t>
              </a: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Gorilla</a:t>
              </a:r>
              <a:r>
                <a:rPr lang="ja-JP" altLang="en-US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IGLL-5          MAWTPLLLPLLTFCTVSEASYELTQSPSVSVSPGQTARITCSG-</a:t>
              </a:r>
              <a:r>
                <a:rPr lang="en-US" altLang="ja-JP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-DALPKK-YAYWYQQK-PGQAPVLVIYEDSKQPSGIPERFSGSSSGTMATLTISGA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96</a:t>
              </a:r>
            </a:p>
            <a:p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Human</a:t>
              </a:r>
              <a:r>
                <a:rPr lang="ja-JP" altLang="en-US" sz="1000" dirty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 </a:t>
              </a:r>
              <a:r>
                <a:rPr lang="en-US" altLang="ja-JP" sz="1000" dirty="0" smtClean="0">
                  <a:latin typeface="ＭＳ ゴシック" panose="020B0609070205080204" pitchFamily="49" charset="-128"/>
                  <a:ea typeface="ＭＳ ゴシック" panose="020B0609070205080204" pitchFamily="49" charset="-128"/>
                  <a:cs typeface="Arial" panose="020B0604020202020204" pitchFamily="34" charset="0"/>
                </a:rPr>
                <a:t>Ig lambda chain   MASFPLLLTLLTHCAGSWAQSVLTQPPSASGTPGQRVTISCSGSRSNVGSN-NVNWYQQL-PGTAPKLLIYSNNQRPSGVPDRFSGSKSGTSASLAISGL 98</a:t>
              </a:r>
            </a:p>
          </p:txBody>
        </p:sp>
      </p:grpSp>
      <p:sp>
        <p:nvSpPr>
          <p:cNvPr id="88" name="テキスト ボックス 2"/>
          <p:cNvSpPr txBox="1"/>
          <p:nvPr/>
        </p:nvSpPr>
        <p:spPr>
          <a:xfrm>
            <a:off x="138429" y="65672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kumimoji="1" lang="en-US" altLang="ja-JP" b="1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正方形/長方形 95"/>
          <p:cNvSpPr/>
          <p:nvPr/>
        </p:nvSpPr>
        <p:spPr>
          <a:xfrm>
            <a:off x="8431223" y="662313"/>
            <a:ext cx="45719" cy="1368000"/>
          </a:xfrm>
          <a:prstGeom prst="rect">
            <a:avLst/>
          </a:prstGeom>
          <a:solidFill>
            <a:schemeClr val="bg1">
              <a:lumMod val="75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17925419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7</TotalTime>
  <Words>143</Words>
  <Application>Microsoft Office PowerPoint</Application>
  <PresentationFormat>A4 210 x 297 mm</PresentationFormat>
  <Paragraphs>32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S30</dc:creator>
  <cp:lastModifiedBy>SS30</cp:lastModifiedBy>
  <cp:revision>137</cp:revision>
  <dcterms:created xsi:type="dcterms:W3CDTF">2016-07-19T00:46:26Z</dcterms:created>
  <dcterms:modified xsi:type="dcterms:W3CDTF">2016-10-25T03:07:45Z</dcterms:modified>
</cp:coreProperties>
</file>